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44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CDEA4F-BE68-41CE-B1F3-A93AFF49A0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31F9F7-BE52-442E-BF05-D70FA50F37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3F396-A7AD-4062-97F1-9F43AE2E8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3C78D5-8783-4DDD-8801-E8E2C2C4C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D8CB88-8086-4990-9827-F0FECD1DA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98335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C699C-6276-49BC-956C-5F020014EA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0189C4-39C1-440F-85A8-5C3436D618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3F1E46-35A0-4F1A-AD58-4ECEC61D6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ECDBB-7682-4B11-AD44-7227C21B9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745F5-511A-405B-A5F8-BBE0EFEDF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369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26CD1E-3517-497F-ACB0-950EEFA42A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AF1D4B-1110-4603-B979-2DAA2F343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2D4C9-8956-4363-A9D3-7F328CF06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5A74C-A8DB-4840-8936-67523DBA0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47025D-30BD-4AD2-9D64-8D49A3B2B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66738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A81D22-F744-41C8-B8A9-BEDEEA5B2C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5F8D48-3173-456F-A642-9D7FF26EA9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245EAB-7CF4-44E1-8277-EAAAA36E8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DF40E1-2F1D-456D-AD94-5F5A10F6F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517BC-9A9F-4C85-B4E0-0BA7E2670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9141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1C754-1512-42B1-804C-23F594F8BE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55FF16-E556-4398-87CD-67AF1E269C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3CBB13-928E-437C-A79D-389A09DDB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23A7DB-FAC5-426F-B10A-3052D8146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9520EE-F71D-47B6-8270-400AF2484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97675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E4ED2A-9857-4FD3-B2D0-86A106EA6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FCD57F-F405-4128-99BA-9EEB31E599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6FF747-C302-4052-98F1-CF2CDB029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EC6DA-6221-47BE-872F-6ADB2C2B3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794293-1F76-4B4B-8A48-7200EF480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8E6FB3-4CC2-4332-AA04-7D2CD1B70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82241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5F84F-68ED-4FD7-BBB9-770C9A42DD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281CE4-C853-4123-A4B0-3BAC67DC9A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EA4610-6A1C-4405-97C1-2F95E72042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1BC089-0C1F-4975-A552-5A0577F7D3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7CF37A-EF1B-4248-A609-A00A706B2E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4D844D-767F-4090-97A6-29EB182BC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63B9E0-B07D-4FDF-9959-5A3B08739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25D066-9F13-4485-A139-4C22765E9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7391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ACCA8F-F664-43EB-8FB9-05CAC5F51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CD84A5-F9B6-4A89-A452-A8BE71B4A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646B6C-94F7-4575-9727-7404B375D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D6DE6F-7CA0-4B8A-B395-4ACB9E391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2873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04DFBE-0B6D-4941-92E7-AC4DF7376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0F173B-1C55-4A76-9056-B24D42F13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75D672-1415-4BBA-A625-248E42F72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8846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05E57-6B2D-4478-BE25-333F879CC2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6F4B2E-596D-4484-AFC1-74B9FD5207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FD881E-CB46-4D7A-8F00-0020555E6B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222F81-02AC-4E4B-90B0-39D97F5B6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50C586-7345-49F4-B6E0-0F2C5859F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5F3D69-5C35-4BFE-B302-4A6EEA75A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56480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2B140-23F8-496C-BA5C-AE506DF76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946CCA-F1A9-4D9F-99B0-A2897F03D1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FDE56-C652-4131-9341-913F7CA276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E9A5CD-F17F-4A49-9ED1-682AB6CC1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85607A-9676-41BF-B9F8-274AADFF0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A1BA09-6A58-4DF6-9480-FED66FDF9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69129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C6E89B-6498-412F-9246-683C0A658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l-G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FDCD45-875C-4D30-8C71-9DD5C3148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l-G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0D74A4-C670-47FE-B192-941FFA8D1E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05719-C8F0-4E5A-93CC-FA9430F8E6C2}" type="datetimeFigureOut">
              <a:rPr lang="el-GR" smtClean="0"/>
              <a:t>10/12/2020</a:t>
            </a:fld>
            <a:endParaRPr lang="el-G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4EE9B3-35A6-431D-A06F-B0DBEA48D1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A7FBEA-E447-4689-B8D9-B60F1793DD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A320D1-D793-447F-94A3-398816FF49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6925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0267" y="2123921"/>
            <a:ext cx="10663090" cy="3505200"/>
          </a:xfr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C8D00E25-2E73-442A-B801-A805B2A05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558800"/>
          </a:xfrm>
        </p:spPr>
        <p:txBody>
          <a:bodyPr>
            <a:normAutofit fontScale="90000"/>
          </a:bodyPr>
          <a:lstStyle/>
          <a:p>
            <a:r>
              <a:rPr lang="en-US" dirty="0"/>
              <a:t>A dynamic view on the HIV continuum of care (adding time in the equation of 90-90-90)</a:t>
            </a:r>
            <a:endParaRPr lang="el-GR" dirty="0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50B29599-C06D-48A3-8F4D-3449BBE13EC1}"/>
              </a:ext>
            </a:extLst>
          </p:cNvPr>
          <p:cNvSpPr/>
          <p:nvPr/>
        </p:nvSpPr>
        <p:spPr>
          <a:xfrm>
            <a:off x="2686049" y="2827375"/>
            <a:ext cx="1628775" cy="1638300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Time from infection to diagnosis</a:t>
            </a:r>
            <a:endParaRPr lang="el-GR"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43D4EEF-6A67-4AA4-8995-0CD45A45368F}"/>
              </a:ext>
            </a:extLst>
          </p:cNvPr>
          <p:cNvSpPr txBox="1"/>
          <p:nvPr/>
        </p:nvSpPr>
        <p:spPr>
          <a:xfrm>
            <a:off x="2493041" y="5562714"/>
            <a:ext cx="25717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oxy</a:t>
            </a:r>
            <a:r>
              <a:rPr lang="en-US" sz="1200" dirty="0"/>
              <a:t>: CD4 count/AIDS at diagnosis, Molecular clock </a:t>
            </a:r>
            <a:endParaRPr lang="el-GR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6B3AC3-E74F-42E1-91D8-74F674791D50}"/>
              </a:ext>
            </a:extLst>
          </p:cNvPr>
          <p:cNvSpPr txBox="1"/>
          <p:nvPr/>
        </p:nvSpPr>
        <p:spPr>
          <a:xfrm>
            <a:off x="5086350" y="5559869"/>
            <a:ext cx="2571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oxy</a:t>
            </a:r>
            <a:r>
              <a:rPr lang="en-US" sz="1200" dirty="0"/>
              <a:t>: Time to ART initiation</a:t>
            </a:r>
            <a:endParaRPr lang="el-GR" sz="1200" dirty="0"/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AD149D7C-9BA6-4B55-AEC4-E72CAF53028C}"/>
              </a:ext>
            </a:extLst>
          </p:cNvPr>
          <p:cNvSpPr/>
          <p:nvPr/>
        </p:nvSpPr>
        <p:spPr>
          <a:xfrm>
            <a:off x="5064791" y="3057130"/>
            <a:ext cx="1628775" cy="1781474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Time from diagnosis to ART initiation</a:t>
            </a:r>
            <a:endParaRPr lang="el-GR" sz="1400" dirty="0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EE122F64-7841-4CE5-A609-9913B8626D8D}"/>
              </a:ext>
            </a:extLst>
          </p:cNvPr>
          <p:cNvSpPr/>
          <p:nvPr/>
        </p:nvSpPr>
        <p:spPr>
          <a:xfrm>
            <a:off x="7386970" y="3344588"/>
            <a:ext cx="1628775" cy="1828006"/>
          </a:xfrm>
          <a:prstGeom prst="rightArrow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dirty="0"/>
              <a:t>Time from ART initiation to confirmed suppression</a:t>
            </a:r>
            <a:endParaRPr lang="el-GR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2429E05-7ADD-4DE5-857B-093297258DE4}"/>
              </a:ext>
            </a:extLst>
          </p:cNvPr>
          <p:cNvSpPr txBox="1"/>
          <p:nvPr/>
        </p:nvSpPr>
        <p:spPr>
          <a:xfrm>
            <a:off x="7386970" y="5515806"/>
            <a:ext cx="2571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oxy</a:t>
            </a:r>
            <a:r>
              <a:rPr lang="en-US" sz="1200" dirty="0"/>
              <a:t>: Time to suppression</a:t>
            </a:r>
            <a:endParaRPr lang="el-GR" sz="12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7AAEE1-6100-4E86-BB77-FE50EA00AD9D}"/>
              </a:ext>
            </a:extLst>
          </p:cNvPr>
          <p:cNvSpPr txBox="1"/>
          <p:nvPr/>
        </p:nvSpPr>
        <p:spPr>
          <a:xfrm>
            <a:off x="9448800" y="5437055"/>
            <a:ext cx="25717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oxy</a:t>
            </a:r>
            <a:r>
              <a:rPr lang="en-US" sz="1200" dirty="0"/>
              <a:t>: Persistence, continuous suppression</a:t>
            </a:r>
            <a:endParaRPr lang="el-GR" sz="1200" dirty="0"/>
          </a:p>
        </p:txBody>
      </p: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586DFC81-983A-4669-ACE5-FD1FF515D271}"/>
              </a:ext>
            </a:extLst>
          </p:cNvPr>
          <p:cNvSpPr/>
          <p:nvPr/>
        </p:nvSpPr>
        <p:spPr>
          <a:xfrm>
            <a:off x="6981825" y="1771650"/>
            <a:ext cx="771525" cy="323850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90 (95)</a:t>
            </a:r>
            <a:endParaRPr lang="el-GR" sz="1400" dirty="0"/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DEC2AD81-5C71-4CD0-88CC-1E6519A521D8}"/>
              </a:ext>
            </a:extLst>
          </p:cNvPr>
          <p:cNvSpPr/>
          <p:nvPr/>
        </p:nvSpPr>
        <p:spPr>
          <a:xfrm>
            <a:off x="4381500" y="1771650"/>
            <a:ext cx="771525" cy="323850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90 (95)</a:t>
            </a:r>
            <a:endParaRPr lang="el-GR" sz="1400" dirty="0"/>
          </a:p>
        </p:txBody>
      </p:sp>
      <p:sp>
        <p:nvSpPr>
          <p:cNvPr id="24" name="Rectangle: Rounded Corners 23">
            <a:extLst>
              <a:ext uri="{FF2B5EF4-FFF2-40B4-BE49-F238E27FC236}">
                <a16:creationId xmlns:a16="http://schemas.microsoft.com/office/drawing/2014/main" id="{D08F45FF-E37D-4386-88C7-F8421BF34734}"/>
              </a:ext>
            </a:extLst>
          </p:cNvPr>
          <p:cNvSpPr/>
          <p:nvPr/>
        </p:nvSpPr>
        <p:spPr>
          <a:xfrm>
            <a:off x="9506244" y="1771650"/>
            <a:ext cx="771525" cy="323850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90 (95)</a:t>
            </a:r>
            <a:endParaRPr lang="el-GR" sz="1400" dirty="0"/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60E1ED66-AA15-4492-B5F3-EFFFC96D4860}"/>
              </a:ext>
            </a:extLst>
          </p:cNvPr>
          <p:cNvSpPr/>
          <p:nvPr/>
        </p:nvSpPr>
        <p:spPr>
          <a:xfrm>
            <a:off x="2686050" y="1533525"/>
            <a:ext cx="1628775" cy="8000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Short (</a:t>
            </a:r>
            <a:r>
              <a:rPr lang="el-GR" sz="1400" dirty="0"/>
              <a:t>? </a:t>
            </a:r>
            <a:r>
              <a:rPr lang="en-US" sz="1400" dirty="0"/>
              <a:t>weeks)</a:t>
            </a:r>
            <a:endParaRPr lang="el-GR" sz="1400" dirty="0"/>
          </a:p>
        </p:txBody>
      </p:sp>
      <p:sp>
        <p:nvSpPr>
          <p:cNvPr id="26" name="Arrow: Right 25">
            <a:extLst>
              <a:ext uri="{FF2B5EF4-FFF2-40B4-BE49-F238E27FC236}">
                <a16:creationId xmlns:a16="http://schemas.microsoft.com/office/drawing/2014/main" id="{A5168CC7-4FED-4469-BB89-36CB709AA879}"/>
              </a:ext>
            </a:extLst>
          </p:cNvPr>
          <p:cNvSpPr/>
          <p:nvPr/>
        </p:nvSpPr>
        <p:spPr>
          <a:xfrm>
            <a:off x="5253037" y="1533525"/>
            <a:ext cx="1628775" cy="8000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Short (</a:t>
            </a:r>
            <a:r>
              <a:rPr lang="el-GR" sz="1400" dirty="0"/>
              <a:t>? </a:t>
            </a:r>
            <a:r>
              <a:rPr lang="en-US" sz="1400" dirty="0"/>
              <a:t>days)</a:t>
            </a:r>
            <a:endParaRPr lang="el-GR" sz="1400" dirty="0"/>
          </a:p>
        </p:txBody>
      </p:sp>
      <p:sp>
        <p:nvSpPr>
          <p:cNvPr id="27" name="Arrow: Right 26">
            <a:extLst>
              <a:ext uri="{FF2B5EF4-FFF2-40B4-BE49-F238E27FC236}">
                <a16:creationId xmlns:a16="http://schemas.microsoft.com/office/drawing/2014/main" id="{2839EC79-76B6-4697-BB5E-C1291BAF833D}"/>
              </a:ext>
            </a:extLst>
          </p:cNvPr>
          <p:cNvSpPr/>
          <p:nvPr/>
        </p:nvSpPr>
        <p:spPr>
          <a:xfrm>
            <a:off x="7853363" y="1546225"/>
            <a:ext cx="1628775" cy="8000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Short (</a:t>
            </a:r>
            <a:r>
              <a:rPr lang="el-GR" sz="1400" dirty="0"/>
              <a:t>? </a:t>
            </a:r>
            <a:r>
              <a:rPr lang="en-US" sz="1400" dirty="0"/>
              <a:t>weeks)</a:t>
            </a:r>
            <a:endParaRPr lang="el-GR" sz="1400" dirty="0"/>
          </a:p>
        </p:txBody>
      </p:sp>
      <p:sp>
        <p:nvSpPr>
          <p:cNvPr id="28" name="Arrow: Right 27">
            <a:extLst>
              <a:ext uri="{FF2B5EF4-FFF2-40B4-BE49-F238E27FC236}">
                <a16:creationId xmlns:a16="http://schemas.microsoft.com/office/drawing/2014/main" id="{38E7ECA8-55D8-47A9-A27C-0CCBD9449585}"/>
              </a:ext>
            </a:extLst>
          </p:cNvPr>
          <p:cNvSpPr/>
          <p:nvPr/>
        </p:nvSpPr>
        <p:spPr>
          <a:xfrm>
            <a:off x="10325786" y="1532335"/>
            <a:ext cx="1628775" cy="80009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Long (years)</a:t>
            </a:r>
            <a:endParaRPr lang="el-GR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9209987" y="3591612"/>
            <a:ext cx="2271859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Time of durable and persistent suppression</a:t>
            </a:r>
            <a:endParaRPr lang="el-GR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3366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9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 dynamic view on the HIV continuum of care (adding time in the equation of 90-90-90)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dynamic view on the HIV continuum of care (adding time in the equation of 90-90-90)</dc:title>
  <dc:creator>Ioannis Katsarolis</dc:creator>
  <cp:lastModifiedBy>G V</cp:lastModifiedBy>
  <cp:revision>7</cp:revision>
  <dcterms:created xsi:type="dcterms:W3CDTF">2020-08-04T06:44:42Z</dcterms:created>
  <dcterms:modified xsi:type="dcterms:W3CDTF">2020-12-10T09:45:35Z</dcterms:modified>
</cp:coreProperties>
</file>